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442" r:id="rId2"/>
    <p:sldId id="443" r:id="rId3"/>
    <p:sldId id="444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 Table" id="{D48EF568-BA8C-F34F-A2B4-6182AD894170}">
          <p14:sldIdLst>
            <p14:sldId id="442"/>
            <p14:sldId id="443"/>
            <p14:sldId id="444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8"/>
  </p:normalViewPr>
  <p:slideViewPr>
    <p:cSldViewPr snapToGrid="0">
      <p:cViewPr varScale="1">
        <p:scale>
          <a:sx n="117" d="100"/>
          <a:sy n="117" d="100"/>
        </p:scale>
        <p:origin x="3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3478D0-340C-6542-8BDE-86EE59BE23A9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9F2724-2B50-4B45-A300-3FDBAD3D84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6324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ry Table 1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aseline characteristics of patients with metastatic biliary tract cancer aged 70</a:t>
            </a:r>
            <a:r>
              <a:rPr lang="ja-JP" altLang="ja-JP" sz="1800">
                <a:effectLst/>
                <a:ea typeface="Times New Roman" panose="02020603050405020304" pitchFamily="18" charset="0"/>
              </a:rPr>
              <a:t>–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74 years before and after propensity score matching</a:t>
            </a:r>
            <a:r>
              <a:rPr lang="ja-JP" altLang="ja-JP">
                <a:effectLst/>
              </a:rPr>
              <a:t> </a:t>
            </a:r>
            <a:endParaRPr lang="en-US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3D66B6-A850-4849-A7F0-6AA8129B48CE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02701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ry Table 2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aseline characteristics of patients with metastatic biliary tract cancer aged 75</a:t>
            </a:r>
            <a:r>
              <a:rPr lang="ja-JP" altLang="ja-JP" sz="1800">
                <a:effectLst/>
                <a:ea typeface="Times New Roman" panose="02020603050405020304" pitchFamily="18" charset="0"/>
              </a:rPr>
              <a:t>–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79 years before and after propensity score matching</a:t>
            </a:r>
            <a:r>
              <a:rPr lang="ja-JP" altLang="ja-JP">
                <a:effectLst/>
              </a:rPr>
              <a:t> </a:t>
            </a:r>
            <a:endParaRPr lang="en-US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3D66B6-A850-4849-A7F0-6AA8129B48CE}" type="slidenum">
              <a:rPr kumimoji="1" lang="ja-JP" altLang="en-US" smtClean="0"/>
              <a:t>2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659404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ry Table 3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aseline characteristics of patients with metastatic biliary tract cancer aged 80</a:t>
            </a:r>
            <a:r>
              <a:rPr lang="ja-JP" altLang="ja-JP" sz="1800">
                <a:effectLst/>
                <a:ea typeface="Times New Roman" panose="02020603050405020304" pitchFamily="18" charset="0"/>
              </a:rPr>
              <a:t>–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84 years before and after propensity score matching</a:t>
            </a:r>
            <a:r>
              <a:rPr lang="ja-JP" altLang="ja-JP">
                <a:effectLst/>
              </a:rPr>
              <a:t> </a:t>
            </a:r>
            <a:endParaRPr lang="en-US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3D66B6-A850-4849-A7F0-6AA8129B48CE}" type="slidenum">
              <a:rPr kumimoji="1" lang="ja-JP" altLang="en-US" smtClean="0"/>
              <a:t>3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930254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EFA675-A16D-2547-11EE-70ED013626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55476F1-0364-DFF8-AEA4-E0C6ECA31F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2EB2B76-C8E4-22CA-87A4-C6253DBA0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7F9DB8-BF50-477A-46E0-EDD13E7DD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77A46E-D62C-3722-A865-6CE0D8E9B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3745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FB74FC-CB41-B27D-DA16-3216FEDE1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1107FA0-7AD7-7875-42BD-C75A03F8E3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CA3EB7-5448-8DD0-9EF3-5BBF547E9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F2E2E4-A83C-DC07-F759-DF45FA779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606D07-F179-9EB6-D15F-41D0506B3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009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E1C9153-D579-6166-DB72-5B93E2E83A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A89A240-205B-D97F-7437-944E798CCC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307572-BBE5-2440-E30A-133085D4B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D523E1-C387-3C06-CB86-A0E908DFE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DE222D-E81F-5A58-5DA1-0C7721EC3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106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F380F6-9F16-AC8F-80B9-234CF2ED8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809949-42A0-B8A6-7F4D-B21D70A4C3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0AFF53-053D-8DD1-3163-EAA01AC84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CEB605-80A4-D823-D021-2435AD67B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284739-114B-560E-BA09-2119DC350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262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6C4EFE-55B7-250A-5D60-F6C2B6B2DA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7F4E008-9A47-32C6-B642-E9378CAAA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7AA908-116E-9DE2-F6D2-D124E4ABA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9C23CB-7096-5FB9-A0A5-1133DDF0C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89C0C9-F1A7-AC3D-44C6-5EBBA3F7D3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0939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E7EA12-5F60-7556-330F-E3DC408EA9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3358601-0555-8FCF-8014-3F84817F32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86085CD-2452-111E-4365-DE90EE1244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4EAD5E-7B67-7FEF-D7FD-A23BC6415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1E91200-8717-F2C2-B4A9-A5A16B9941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DB6CAFF-9DD3-F3FB-1A8B-B5FDC8F00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721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83F93D-2B6E-CB65-54A0-3C456EDE9E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5927A07-BF2A-57BF-9D51-7E7017AC4C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AB33E81-05C3-4F6E-398B-CCB3B4692A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299198A-796F-E52E-03C9-D3E668E97B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30DFB17-478B-AEA8-F27A-AE392223D0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7C9450A-7117-10A7-2155-66EDF859FC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740607D-CF6A-0FE4-B5A0-AFC6983A6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304AB08-7A09-248D-7CA5-5B95EE335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4854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858065-DE63-4B5C-4663-74CE6BBB35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DF16520-F03D-DA73-E68A-6D463BA5D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D16393-A56E-9F8B-5208-C4CA91401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EE89922-F182-1959-0066-3F06AA3AF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34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8D727F8-7FC0-F1A4-87FD-97E310E58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85DB4FA-A74B-75BD-3437-586820CD4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449BBA8-1D19-F423-0947-CF48BFB9B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548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6F4ABF-DC73-17D4-728C-4254A80DD4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2A7390-BCC1-D90E-7B23-B703D68500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0C8C694-E37B-40BC-2F74-8D781D0424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010E2BC-5463-4277-7BEC-FD01CDD93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B7E1D4-AEC2-D89F-3233-DEA64105A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CFF057A-97AA-9A86-7F4C-0B93645FC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4458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206B48-79D3-5A28-7977-044A9FDF0D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72E544B-3B06-2AD3-48EE-FCD750C7B0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792F289-A3E8-D07F-CEAD-0754B2E56F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A7955AD-8B5A-9B55-D841-C9E300B7F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7297791-18C7-D915-D602-B53A6E18A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CC4F161-BC1B-3CC2-9A2A-46E61431E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5702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8789451-0482-8011-EC78-7D2FCFC3FA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A04E56-CE61-5864-C619-A0610684DB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99B3CE4-6ACA-9E39-3A84-597714274E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C1673-44B9-E246-922B-A44B5FF342B6}" type="datetimeFigureOut">
              <a:rPr kumimoji="1" lang="ja-JP" altLang="en-US" smtClean="0"/>
              <a:t>2023/3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0A8CEA-59E2-8320-367F-26A7FDF19F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D68357-C03A-30A2-195F-54B3D210B4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7F2A39-3ED1-3341-9FC0-6867259E41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4466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E8A02637-23E3-2A33-0125-B43EC8F1B23A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441446559"/>
              </p:ext>
            </p:extLst>
          </p:nvPr>
        </p:nvGraphicFramePr>
        <p:xfrm>
          <a:off x="674913" y="984283"/>
          <a:ext cx="10025745" cy="4619917"/>
        </p:xfrm>
        <a:graphic>
          <a:graphicData uri="http://schemas.openxmlformats.org/drawingml/2006/table">
            <a:tbl>
              <a:tblPr/>
              <a:tblGrid>
                <a:gridCol w="1981580">
                  <a:extLst>
                    <a:ext uri="{9D8B030D-6E8A-4147-A177-3AD203B41FA5}">
                      <a16:colId xmlns:a16="http://schemas.microsoft.com/office/drawing/2014/main" val="1895598325"/>
                    </a:ext>
                  </a:extLst>
                </a:gridCol>
                <a:gridCol w="1153507">
                  <a:extLst>
                    <a:ext uri="{9D8B030D-6E8A-4147-A177-3AD203B41FA5}">
                      <a16:colId xmlns:a16="http://schemas.microsoft.com/office/drawing/2014/main" val="2212049217"/>
                    </a:ext>
                  </a:extLst>
                </a:gridCol>
                <a:gridCol w="1240972">
                  <a:extLst>
                    <a:ext uri="{9D8B030D-6E8A-4147-A177-3AD203B41FA5}">
                      <a16:colId xmlns:a16="http://schemas.microsoft.com/office/drawing/2014/main" val="1523020927"/>
                    </a:ext>
                  </a:extLst>
                </a:gridCol>
                <a:gridCol w="729342">
                  <a:extLst>
                    <a:ext uri="{9D8B030D-6E8A-4147-A177-3AD203B41FA5}">
                      <a16:colId xmlns:a16="http://schemas.microsoft.com/office/drawing/2014/main" val="2682891002"/>
                    </a:ext>
                  </a:extLst>
                </a:gridCol>
                <a:gridCol w="707572">
                  <a:extLst>
                    <a:ext uri="{9D8B030D-6E8A-4147-A177-3AD203B41FA5}">
                      <a16:colId xmlns:a16="http://schemas.microsoft.com/office/drawing/2014/main" val="1405966695"/>
                    </a:ext>
                  </a:extLst>
                </a:gridCol>
                <a:gridCol w="174171">
                  <a:extLst>
                    <a:ext uri="{9D8B030D-6E8A-4147-A177-3AD203B41FA5}">
                      <a16:colId xmlns:a16="http://schemas.microsoft.com/office/drawing/2014/main" val="3660856615"/>
                    </a:ext>
                  </a:extLst>
                </a:gridCol>
                <a:gridCol w="1307799">
                  <a:extLst>
                    <a:ext uri="{9D8B030D-6E8A-4147-A177-3AD203B41FA5}">
                      <a16:colId xmlns:a16="http://schemas.microsoft.com/office/drawing/2014/main" val="80457651"/>
                    </a:ext>
                  </a:extLst>
                </a:gridCol>
                <a:gridCol w="1197056">
                  <a:extLst>
                    <a:ext uri="{9D8B030D-6E8A-4147-A177-3AD203B41FA5}">
                      <a16:colId xmlns:a16="http://schemas.microsoft.com/office/drawing/2014/main" val="4160017818"/>
                    </a:ext>
                  </a:extLst>
                </a:gridCol>
                <a:gridCol w="766873">
                  <a:extLst>
                    <a:ext uri="{9D8B030D-6E8A-4147-A177-3AD203B41FA5}">
                      <a16:colId xmlns:a16="http://schemas.microsoft.com/office/drawing/2014/main" val="795965191"/>
                    </a:ext>
                  </a:extLst>
                </a:gridCol>
                <a:gridCol w="766873">
                  <a:extLst>
                    <a:ext uri="{9D8B030D-6E8A-4147-A177-3AD203B41FA5}">
                      <a16:colId xmlns:a16="http://schemas.microsoft.com/office/drawing/2014/main" val="1205405669"/>
                    </a:ext>
                  </a:extLst>
                </a:gridCol>
              </a:tblGrid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riginal Data Set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atched Data Set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7152618"/>
                  </a:ext>
                </a:extLst>
              </a:tr>
              <a:tr h="405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ariables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emotherapy (n=47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 </a:t>
                      </a:r>
                    </a:p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n=16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*P valu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emotherapy (n=12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 </a:t>
                      </a:r>
                    </a:p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n=12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†P valu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6054215"/>
                  </a:ext>
                </a:extLst>
              </a:tr>
              <a:tr h="3225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ge,mean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(SD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1.9 (1.52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2.2 (1.52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9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07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1.4 (1.31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2.2 (1.59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1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623288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ex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7004312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Mal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8 (59.6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 (68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92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6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7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66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8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5962517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Femal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9 (40.4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31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2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 (33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4894765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ody mass index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4072330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1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17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 (3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73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2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2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904290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9 (83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 (6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7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7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8725697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umor Location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213221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allblad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 (27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31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7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7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 (8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2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5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4939694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Non-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allblad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4 (72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 (68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 (91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7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8649626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arthel Index, n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0138138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3 (91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 (68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9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3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7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7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0017500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≤</a:t>
                      </a:r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 (8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31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2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2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72562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CI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9980758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0 (63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 (3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4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8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 (33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5 (41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73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8271180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7 (36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 (6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66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7 (58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6620342"/>
                  </a:ext>
                </a:extLst>
              </a:tr>
              <a:tr h="322530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, best supportive care; SD, standard deviations; CCI, 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arlson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Comorbidity Index; 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, standardized difference;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289630"/>
                  </a:ext>
                </a:extLst>
              </a:tr>
              <a:tr h="204787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*P value for Student t-test or Chi-square test; †P value for Mantel-Haenszel test.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85023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94981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21C4E57A-C63D-51FD-541C-56810905FCA5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244264364"/>
              </p:ext>
            </p:extLst>
          </p:nvPr>
        </p:nvGraphicFramePr>
        <p:xfrm>
          <a:off x="674913" y="984283"/>
          <a:ext cx="10025745" cy="4619917"/>
        </p:xfrm>
        <a:graphic>
          <a:graphicData uri="http://schemas.openxmlformats.org/drawingml/2006/table">
            <a:tbl>
              <a:tblPr/>
              <a:tblGrid>
                <a:gridCol w="1981580">
                  <a:extLst>
                    <a:ext uri="{9D8B030D-6E8A-4147-A177-3AD203B41FA5}">
                      <a16:colId xmlns:a16="http://schemas.microsoft.com/office/drawing/2014/main" val="1895598325"/>
                    </a:ext>
                  </a:extLst>
                </a:gridCol>
                <a:gridCol w="1153507">
                  <a:extLst>
                    <a:ext uri="{9D8B030D-6E8A-4147-A177-3AD203B41FA5}">
                      <a16:colId xmlns:a16="http://schemas.microsoft.com/office/drawing/2014/main" val="2212049217"/>
                    </a:ext>
                  </a:extLst>
                </a:gridCol>
                <a:gridCol w="1240972">
                  <a:extLst>
                    <a:ext uri="{9D8B030D-6E8A-4147-A177-3AD203B41FA5}">
                      <a16:colId xmlns:a16="http://schemas.microsoft.com/office/drawing/2014/main" val="1523020927"/>
                    </a:ext>
                  </a:extLst>
                </a:gridCol>
                <a:gridCol w="729342">
                  <a:extLst>
                    <a:ext uri="{9D8B030D-6E8A-4147-A177-3AD203B41FA5}">
                      <a16:colId xmlns:a16="http://schemas.microsoft.com/office/drawing/2014/main" val="2682891002"/>
                    </a:ext>
                  </a:extLst>
                </a:gridCol>
                <a:gridCol w="707572">
                  <a:extLst>
                    <a:ext uri="{9D8B030D-6E8A-4147-A177-3AD203B41FA5}">
                      <a16:colId xmlns:a16="http://schemas.microsoft.com/office/drawing/2014/main" val="1405966695"/>
                    </a:ext>
                  </a:extLst>
                </a:gridCol>
                <a:gridCol w="174171">
                  <a:extLst>
                    <a:ext uri="{9D8B030D-6E8A-4147-A177-3AD203B41FA5}">
                      <a16:colId xmlns:a16="http://schemas.microsoft.com/office/drawing/2014/main" val="3660856615"/>
                    </a:ext>
                  </a:extLst>
                </a:gridCol>
                <a:gridCol w="1307799">
                  <a:extLst>
                    <a:ext uri="{9D8B030D-6E8A-4147-A177-3AD203B41FA5}">
                      <a16:colId xmlns:a16="http://schemas.microsoft.com/office/drawing/2014/main" val="80457651"/>
                    </a:ext>
                  </a:extLst>
                </a:gridCol>
                <a:gridCol w="1197056">
                  <a:extLst>
                    <a:ext uri="{9D8B030D-6E8A-4147-A177-3AD203B41FA5}">
                      <a16:colId xmlns:a16="http://schemas.microsoft.com/office/drawing/2014/main" val="4160017818"/>
                    </a:ext>
                  </a:extLst>
                </a:gridCol>
                <a:gridCol w="766873">
                  <a:extLst>
                    <a:ext uri="{9D8B030D-6E8A-4147-A177-3AD203B41FA5}">
                      <a16:colId xmlns:a16="http://schemas.microsoft.com/office/drawing/2014/main" val="795965191"/>
                    </a:ext>
                  </a:extLst>
                </a:gridCol>
                <a:gridCol w="766873">
                  <a:extLst>
                    <a:ext uri="{9D8B030D-6E8A-4147-A177-3AD203B41FA5}">
                      <a16:colId xmlns:a16="http://schemas.microsoft.com/office/drawing/2014/main" val="1205405669"/>
                    </a:ext>
                  </a:extLst>
                </a:gridCol>
              </a:tblGrid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riginal Data Set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atched Data Set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7152618"/>
                  </a:ext>
                </a:extLst>
              </a:tr>
              <a:tr h="405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ariables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emotherapy (n=43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 </a:t>
                      </a:r>
                    </a:p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n=29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*P valu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emotherapy (n=23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 </a:t>
                      </a:r>
                    </a:p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n=23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†P valu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6054215"/>
                  </a:ext>
                </a:extLst>
              </a:tr>
              <a:tr h="3225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ge,mean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(SD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7.0 (1.31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7.0 (1.51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1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947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6.9 (1.18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7.3 (1.32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312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9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623288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ex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7004312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Mal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4 (55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8 (62.1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27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3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4 (60.9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 (56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88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5962517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Femal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9 (44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 (37.9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39.1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 (43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4894765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ody mass index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4072330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1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 (4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 (3.4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6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 (4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 (4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904290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1 (95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8 (96.6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2 (95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2 (95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8725697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umor Location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213221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allblad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7 (39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31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7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18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 (26.1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34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74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4939694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Non-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allblad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6 (60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 (69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7 (73.9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5 (65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8649626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arthel Index, n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0138138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9 (90.7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2 (75.9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0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0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 (87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9 (82.6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2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0017500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≤</a:t>
                      </a:r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 (9.3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 (24.1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13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 (17.4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72562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CI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9980758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9 (67.4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 (55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5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32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5 (65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15 (65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8271180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4 (32.6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 (44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34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5 (34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6620342"/>
                  </a:ext>
                </a:extLst>
              </a:tr>
              <a:tr h="322530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, best supportive care; SD, standard deviations; CCI, 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arlson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Comorbidity Index; 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, standardized difference;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289630"/>
                  </a:ext>
                </a:extLst>
              </a:tr>
              <a:tr h="204787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*P value for Student t-test or Chi-square test; †P value for Mantel-Haenszel test.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85023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40798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D7ACA564-73E4-4EB9-1232-BB53D2CF51F7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440110599"/>
              </p:ext>
            </p:extLst>
          </p:nvPr>
        </p:nvGraphicFramePr>
        <p:xfrm>
          <a:off x="674913" y="984283"/>
          <a:ext cx="10025745" cy="4619917"/>
        </p:xfrm>
        <a:graphic>
          <a:graphicData uri="http://schemas.openxmlformats.org/drawingml/2006/table">
            <a:tbl>
              <a:tblPr/>
              <a:tblGrid>
                <a:gridCol w="1981580">
                  <a:extLst>
                    <a:ext uri="{9D8B030D-6E8A-4147-A177-3AD203B41FA5}">
                      <a16:colId xmlns:a16="http://schemas.microsoft.com/office/drawing/2014/main" val="1895598325"/>
                    </a:ext>
                  </a:extLst>
                </a:gridCol>
                <a:gridCol w="1153507">
                  <a:extLst>
                    <a:ext uri="{9D8B030D-6E8A-4147-A177-3AD203B41FA5}">
                      <a16:colId xmlns:a16="http://schemas.microsoft.com/office/drawing/2014/main" val="2212049217"/>
                    </a:ext>
                  </a:extLst>
                </a:gridCol>
                <a:gridCol w="1240972">
                  <a:extLst>
                    <a:ext uri="{9D8B030D-6E8A-4147-A177-3AD203B41FA5}">
                      <a16:colId xmlns:a16="http://schemas.microsoft.com/office/drawing/2014/main" val="1523020927"/>
                    </a:ext>
                  </a:extLst>
                </a:gridCol>
                <a:gridCol w="729342">
                  <a:extLst>
                    <a:ext uri="{9D8B030D-6E8A-4147-A177-3AD203B41FA5}">
                      <a16:colId xmlns:a16="http://schemas.microsoft.com/office/drawing/2014/main" val="2682891002"/>
                    </a:ext>
                  </a:extLst>
                </a:gridCol>
                <a:gridCol w="707572">
                  <a:extLst>
                    <a:ext uri="{9D8B030D-6E8A-4147-A177-3AD203B41FA5}">
                      <a16:colId xmlns:a16="http://schemas.microsoft.com/office/drawing/2014/main" val="1405966695"/>
                    </a:ext>
                  </a:extLst>
                </a:gridCol>
                <a:gridCol w="174171">
                  <a:extLst>
                    <a:ext uri="{9D8B030D-6E8A-4147-A177-3AD203B41FA5}">
                      <a16:colId xmlns:a16="http://schemas.microsoft.com/office/drawing/2014/main" val="3660856615"/>
                    </a:ext>
                  </a:extLst>
                </a:gridCol>
                <a:gridCol w="1307799">
                  <a:extLst>
                    <a:ext uri="{9D8B030D-6E8A-4147-A177-3AD203B41FA5}">
                      <a16:colId xmlns:a16="http://schemas.microsoft.com/office/drawing/2014/main" val="80457651"/>
                    </a:ext>
                  </a:extLst>
                </a:gridCol>
                <a:gridCol w="1197056">
                  <a:extLst>
                    <a:ext uri="{9D8B030D-6E8A-4147-A177-3AD203B41FA5}">
                      <a16:colId xmlns:a16="http://schemas.microsoft.com/office/drawing/2014/main" val="4160017818"/>
                    </a:ext>
                  </a:extLst>
                </a:gridCol>
                <a:gridCol w="766873">
                  <a:extLst>
                    <a:ext uri="{9D8B030D-6E8A-4147-A177-3AD203B41FA5}">
                      <a16:colId xmlns:a16="http://schemas.microsoft.com/office/drawing/2014/main" val="795965191"/>
                    </a:ext>
                  </a:extLst>
                </a:gridCol>
                <a:gridCol w="766873">
                  <a:extLst>
                    <a:ext uri="{9D8B030D-6E8A-4147-A177-3AD203B41FA5}">
                      <a16:colId xmlns:a16="http://schemas.microsoft.com/office/drawing/2014/main" val="1205405669"/>
                    </a:ext>
                  </a:extLst>
                </a:gridCol>
              </a:tblGrid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riginal Data Set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atched Data Set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7152618"/>
                  </a:ext>
                </a:extLst>
              </a:tr>
              <a:tr h="405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ariables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emotherapy (n=16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 </a:t>
                      </a:r>
                    </a:p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n=29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*P valu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emotherapy (n=8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 </a:t>
                      </a:r>
                    </a:p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n=8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†P valu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6054215"/>
                  </a:ext>
                </a:extLst>
              </a:tr>
              <a:tr h="3225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ge,mean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(SD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2.3 (1.57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1.7 (1.41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352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57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2.0 (1.77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2.3 (1.49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53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76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623288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ex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7004312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Mal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5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 (44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0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76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6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3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1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1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5962517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Female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5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 (55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3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6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4894765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ody mass index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4072330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1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 (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17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4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4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 (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 (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904290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 (10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4 (82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10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10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8725697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umor Location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2132216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allblad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56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31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2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22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3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3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4939694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Non-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allblad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 (43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 (69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6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6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8649626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arthel Index, n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0138138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5 (93.8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9 (65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74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67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 (8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 (10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3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0017500"/>
                  </a:ext>
                </a:extLst>
              </a:tr>
              <a:tr h="2342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≤</a:t>
                      </a:r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 (6.2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 (34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 (1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 (0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72562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CI, n (%)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9980758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 (3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 (69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65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 (6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6 (7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72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8271180"/>
                  </a:ext>
                </a:extLst>
              </a:tr>
              <a:tr h="20478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≥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 (62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 (31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 (37.5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2 (25.0) 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6620342"/>
                  </a:ext>
                </a:extLst>
              </a:tr>
              <a:tr h="322530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SC, best supportive care; SD, standard deviations; CCI, 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arlson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Comorbidity Index; 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diff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, standardized difference; NA, not available;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289630"/>
                  </a:ext>
                </a:extLst>
              </a:tr>
              <a:tr h="204787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*P value for Student t-test or Chi-square test; †P value for Mantel-Haenszel test.</a:t>
                      </a:r>
                    </a:p>
                  </a:txBody>
                  <a:tcPr marL="4019" marR="4019" marT="40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85023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24887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1</TotalTime>
  <Words>1393</Words>
  <Application>Microsoft Macintosh PowerPoint</Application>
  <PresentationFormat>ワイド画面</PresentationFormat>
  <Paragraphs>537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患者背景</dc:title>
  <dc:creator>建 平尾</dc:creator>
  <cp:lastModifiedBy>建 平尾</cp:lastModifiedBy>
  <cp:revision>40</cp:revision>
  <dcterms:created xsi:type="dcterms:W3CDTF">2022-11-07T03:26:43Z</dcterms:created>
  <dcterms:modified xsi:type="dcterms:W3CDTF">2023-03-07T02:30:36Z</dcterms:modified>
</cp:coreProperties>
</file>